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6" d="100"/>
          <a:sy n="76" d="100"/>
        </p:scale>
        <p:origin x="917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E550E7-000F-4B4D-B536-FC1D7BE15EF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D498395-39D4-444B-B15E-29455FEECB7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A0B310-D04E-477A-9E24-7BE2AE8B23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B7643-BEEA-4861-AF41-9A0B87D362D8}" type="datetimeFigureOut">
              <a:rPr lang="en-US" smtClean="0"/>
              <a:t>11/2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ACFC60-4F71-4F0B-BAD2-7B55A76799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C24297-2152-4B75-8D84-7DC1E50A5B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AD91A-EFC9-4B21-B7B2-8E6696CE2C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26353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246236-6EA4-462C-9CE3-FBB030E520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4FCBBD0-CFF8-4118-BB06-A7C6A78ADD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42416F-5BEC-49D5-9824-83854F8B78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B7643-BEEA-4861-AF41-9A0B87D362D8}" type="datetimeFigureOut">
              <a:rPr lang="en-US" smtClean="0"/>
              <a:t>11/2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3EE841-672B-4C7C-83DD-D61F010B88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20AFCB-1895-493C-8582-F70FB294A6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AD91A-EFC9-4B21-B7B2-8E6696CE2C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20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EE520A9-B2E5-4512-B9BF-20F07FF2911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5800804-36BD-4815-A971-C643479F51D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E09494-8A5A-4C40-A48B-91275E314C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B7643-BEEA-4861-AF41-9A0B87D362D8}" type="datetimeFigureOut">
              <a:rPr lang="en-US" smtClean="0"/>
              <a:t>11/2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9F86BB-4F67-4059-A000-E0A3B9B2D7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505F25-C5AE-4307-AACF-DB2427DC9F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AD91A-EFC9-4B21-B7B2-8E6696CE2C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5297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8EC438-8EF1-4377-B529-41C47D0174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4783583-F5DA-4553-8FB4-C754A57E180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DC3E6E-AB96-46F0-8B63-9CC8F0BF93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B7643-BEEA-4861-AF41-9A0B87D362D8}" type="datetimeFigureOut">
              <a:rPr lang="en-US" smtClean="0"/>
              <a:t>11/2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25F78D-3C45-4AF1-A24A-92582F4755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F958E7F-C5BF-4E8A-B17D-E86CC10F5D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AD91A-EFC9-4B21-B7B2-8E6696CE2C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65512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44CE73-2699-4EB7-988F-237ECABA70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709DF2-1E48-4210-9CB1-B07814C348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DC0A37F-AF2E-4CE2-A5D8-262FD0E30C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B7643-BEEA-4861-AF41-9A0B87D362D8}" type="datetimeFigureOut">
              <a:rPr lang="en-US" smtClean="0"/>
              <a:t>11/2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1C16A6-06B9-4C0F-92A7-2F5720323C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95C3B1-2291-4362-8EA2-A519842104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AD91A-EFC9-4B21-B7B2-8E6696CE2C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3666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D1E343-8C4E-4E09-8ED7-08536C0D6B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251D56D-AB24-4879-AFC4-FACC3CA759F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A4C3C41-00DC-4E1C-8449-C84BAF3B659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2C62A63-CEB9-45AA-9676-CF8BF948AE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B7643-BEEA-4861-AF41-9A0B87D362D8}" type="datetimeFigureOut">
              <a:rPr lang="en-US" smtClean="0"/>
              <a:t>11/25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E1C5573-8E7A-488A-8D60-565D0EC9FE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DFD561-D4B9-43D7-BE0C-1AD00F09EE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AD91A-EFC9-4B21-B7B2-8E6696CE2C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6676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218829-9C6E-419A-937F-050C99CB15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7FED897-BFF9-4FE4-AF97-36EC7F0E03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A3A7E72-137B-40A8-A675-B3B7F3B5B9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7E6F26B-5334-48D0-A446-EBC255E6EFA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3770F1D-FB0F-4440-92B7-5781320EFB3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124CA5A-01BB-41E4-9610-DC470FB2AD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B7643-BEEA-4861-AF41-9A0B87D362D8}" type="datetimeFigureOut">
              <a:rPr lang="en-US" smtClean="0"/>
              <a:t>11/25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F920C17-0035-4C13-BFF5-D52463A509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D14B420-66D1-4257-BAD7-B78F888DE0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AD91A-EFC9-4B21-B7B2-8E6696CE2C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10335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4D7A07-861C-400F-A7BF-8C4F3A7181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672B0FB-7B26-4D51-99CE-0903735C98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B7643-BEEA-4861-AF41-9A0B87D362D8}" type="datetimeFigureOut">
              <a:rPr lang="en-US" smtClean="0"/>
              <a:t>11/25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2D06C14-6DE9-4821-8C23-A98FDEF2AB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E118CC3-13D6-45A0-8F3C-015A264406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AD91A-EFC9-4B21-B7B2-8E6696CE2C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65432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F56AF21-528C-4912-A6FF-3C37749DC7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B7643-BEEA-4861-AF41-9A0B87D362D8}" type="datetimeFigureOut">
              <a:rPr lang="en-US" smtClean="0"/>
              <a:t>11/25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8F8C4BA-3909-4ECC-96FE-AE8EB99BDE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3232B73-E6C2-466C-BDB6-A721A63744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AD91A-EFC9-4B21-B7B2-8E6696CE2C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24932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AE0592-7AC4-41CA-B1F6-5404BDF4ED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130E2BD-F659-4B9B-8631-4D20940C905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9C47AA6-11C5-4C2D-96B2-63E29AA9D40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71EAD3C-E4EA-4DDD-A10B-8506CA352A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B7643-BEEA-4861-AF41-9A0B87D362D8}" type="datetimeFigureOut">
              <a:rPr lang="en-US" smtClean="0"/>
              <a:t>11/25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C1795FE-6622-4D6C-AE85-ACDD3D1641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C72AC1D-B5F5-47BB-9A37-3E91F441AE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AD91A-EFC9-4B21-B7B2-8E6696CE2C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5651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A5AEE7-771D-4A46-B3FB-A9CD5DAB88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C576C94-B0A4-49B5-BDE4-38300405596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6DFDA53-CF51-4E71-8985-A2C50BD26B2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977211F-B133-4B72-818B-359C5065FA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B7643-BEEA-4861-AF41-9A0B87D362D8}" type="datetimeFigureOut">
              <a:rPr lang="en-US" smtClean="0"/>
              <a:t>11/25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F5D34F0-7DEF-464C-B93B-CE14334257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B1F9B47-503A-48E4-872A-F3206A2594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AD91A-EFC9-4B21-B7B2-8E6696CE2C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67199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3CF5859-A330-4EBC-BD89-A520D53692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F398091-6B70-4B24-9E48-65F9579110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E67150-0042-4061-8B22-EEB3C464235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4B7643-BEEA-4861-AF41-9A0B87D362D8}" type="datetimeFigureOut">
              <a:rPr lang="en-US" smtClean="0"/>
              <a:t>11/2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0E96D5-A0E1-4E9A-AF33-2319B3CDE02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38D74B-B036-4B73-9C1E-DA94902B426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DAD91A-EFC9-4B21-B7B2-8E6696CE2C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00376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B2C5114D-5588-45F4-A5AB-7CE47883982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47797121"/>
              </p:ext>
            </p:extLst>
          </p:nvPr>
        </p:nvGraphicFramePr>
        <p:xfrm>
          <a:off x="6793087" y="3012649"/>
          <a:ext cx="2844957" cy="3480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8" r:id="rId3" imgW="3792838" imgH="4640265" progId="Prism8.Document">
                  <p:embed/>
                </p:oleObj>
              </mc:Choice>
              <mc:Fallback>
                <p:oleObj name="Prism 8" r:id="rId3" imgW="3792838" imgH="464026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793087" y="3012649"/>
                        <a:ext cx="2844957" cy="3480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FF921321-F6F6-434B-8FEC-6C61B38ECA4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27029324"/>
              </p:ext>
            </p:extLst>
          </p:nvPr>
        </p:nvGraphicFramePr>
        <p:xfrm>
          <a:off x="974690" y="673240"/>
          <a:ext cx="9385161" cy="2154744"/>
        </p:xfrm>
        <a:graphic>
          <a:graphicData uri="http://schemas.openxmlformats.org/drawingml/2006/table">
            <a:tbl>
              <a:tblPr>
                <a:tableStyleId>{073A0DAA-6AF3-43AB-8588-CEC1D06C72B9}</a:tableStyleId>
              </a:tblPr>
              <a:tblGrid>
                <a:gridCol w="1184535">
                  <a:extLst>
                    <a:ext uri="{9D8B030D-6E8A-4147-A177-3AD203B41FA5}">
                      <a16:colId xmlns:a16="http://schemas.microsoft.com/office/drawing/2014/main" val="1558373430"/>
                    </a:ext>
                  </a:extLst>
                </a:gridCol>
                <a:gridCol w="2772593">
                  <a:extLst>
                    <a:ext uri="{9D8B030D-6E8A-4147-A177-3AD203B41FA5}">
                      <a16:colId xmlns:a16="http://schemas.microsoft.com/office/drawing/2014/main" val="409590545"/>
                    </a:ext>
                  </a:extLst>
                </a:gridCol>
                <a:gridCol w="2817373">
                  <a:extLst>
                    <a:ext uri="{9D8B030D-6E8A-4147-A177-3AD203B41FA5}">
                      <a16:colId xmlns:a16="http://schemas.microsoft.com/office/drawing/2014/main" val="2048635642"/>
                    </a:ext>
                  </a:extLst>
                </a:gridCol>
                <a:gridCol w="2610660">
                  <a:extLst>
                    <a:ext uri="{9D8B030D-6E8A-4147-A177-3AD203B41FA5}">
                      <a16:colId xmlns:a16="http://schemas.microsoft.com/office/drawing/2014/main" val="1734961739"/>
                    </a:ext>
                  </a:extLst>
                </a:gridCol>
              </a:tblGrid>
              <a:tr h="538686">
                <a:tc>
                  <a:txBody>
                    <a:bodyPr/>
                    <a:lstStyle/>
                    <a:p>
                      <a:pPr algn="l" fontAlgn="b"/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 Primer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 Primer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ession Number of sequence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50499534"/>
                  </a:ext>
                </a:extLst>
              </a:tr>
              <a:tr h="538686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TL14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CGGAAACACCTACTGAGG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CTTGCGCCAATTTCTCT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M_005681276.3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63413032"/>
                  </a:ext>
                </a:extLst>
              </a:tr>
              <a:tr h="538686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IRMA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GTGACTGTGCTCAGTGGAT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TTGTTTCCCGACAGACGAT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M_005689233.3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46197098"/>
                  </a:ext>
                </a:extLst>
              </a:tr>
              <a:tr h="538686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THDF1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TGGACCCCCAGAGAACAAAA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GGGTAATAGCTGGACAGG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M_018057562.1 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63255735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4E0EBE47-1923-4A2E-AA37-AAC0CF428297}"/>
              </a:ext>
            </a:extLst>
          </p:cNvPr>
          <p:cNvSpPr txBox="1"/>
          <p:nvPr/>
        </p:nvSpPr>
        <p:spPr>
          <a:xfrm>
            <a:off x="974690" y="70608"/>
            <a:ext cx="4793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1. Sequence of Selected Primer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65CC7A8-F503-47BF-BF00-EC9395A8DC00}"/>
              </a:ext>
            </a:extLst>
          </p:cNvPr>
          <p:cNvSpPr txBox="1"/>
          <p:nvPr/>
        </p:nvSpPr>
        <p:spPr>
          <a:xfrm>
            <a:off x="2553956" y="4383755"/>
            <a:ext cx="4793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2. qPCR of METTL14, VIRMA &amp; YTHDF1</a:t>
            </a:r>
          </a:p>
        </p:txBody>
      </p:sp>
    </p:spTree>
    <p:extLst>
      <p:ext uri="{BB962C8B-B14F-4D97-AF65-F5344CB8AC3E}">
        <p14:creationId xmlns:p14="http://schemas.microsoft.com/office/powerpoint/2010/main" val="26167635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41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rism 8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shaaq Raja</dc:creator>
  <cp:lastModifiedBy>Ishaaq Raja</cp:lastModifiedBy>
  <cp:revision>2</cp:revision>
  <dcterms:created xsi:type="dcterms:W3CDTF">2021-11-25T17:51:34Z</dcterms:created>
  <dcterms:modified xsi:type="dcterms:W3CDTF">2021-11-25T17:57:34Z</dcterms:modified>
</cp:coreProperties>
</file>